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3" r:id="rId2"/>
    <p:sldId id="286" r:id="rId3"/>
    <p:sldId id="294" r:id="rId4"/>
    <p:sldId id="28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5" d="100"/>
          <a:sy n="95" d="100"/>
        </p:scale>
        <p:origin x="1090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173419\Desktop\SSC_data\SSc%20manuscript%20Version%205_June%202017%20-%20Copy\New%20Microsoft%20Excel%20Workshee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173419\Desktop\SSC_data\SSc%20manuscript%20Version%205_June%202017%20-%20Copy\New%20Microsoft%20Excel%20Workshee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esearch%20group\Xiangya%20Hospital\Honglin%20Zhu\SSC%20manuscript\International%20journal%20of%20Rheumatology\Supplementary%20Table%204_Distribution%20of%20DMG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esearch%20group\Xiangya%20Hospital\Honglin%20Zhu\SSC%20manuscript\International%20journal%20of%20Rheumatology\Supplementary%20Table%204_Distribution%20of%20DMG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173419\Desktop\SSC_data\DMG_list\david_methylated_gene_lis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173419\Desktop\SSC_data\DMG_list\david_methylated_gene_lis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Gene ontologies of downregulated</a:t>
            </a:r>
            <a:r>
              <a:rPr lang="en-US" baseline="0" dirty="0" smtClean="0"/>
              <a:t> </a:t>
            </a:r>
            <a:r>
              <a:rPr lang="en-US" baseline="0" dirty="0"/>
              <a:t>genes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downregulated_genes_BP_all!$A$2:$A$16</c:f>
              <c:strCache>
                <c:ptCount val="15"/>
                <c:pt idx="0">
                  <c:v>alpha-beta T cell differentiation</c:v>
                </c:pt>
                <c:pt idx="1">
                  <c:v>cellular defense response</c:v>
                </c:pt>
                <c:pt idx="2">
                  <c:v>natural killer cell mediated immunity</c:v>
                </c:pt>
                <c:pt idx="3">
                  <c:v>response to stress</c:v>
                </c:pt>
                <c:pt idx="4">
                  <c:v>T cell aggregation</c:v>
                </c:pt>
                <c:pt idx="5">
                  <c:v>T cell activation</c:v>
                </c:pt>
                <c:pt idx="6">
                  <c:v>immune response</c:v>
                </c:pt>
                <c:pt idx="7">
                  <c:v>lymphocyte aggregation</c:v>
                </c:pt>
                <c:pt idx="8">
                  <c:v>leukocyte aggregation</c:v>
                </c:pt>
                <c:pt idx="9">
                  <c:v>regulation of biological process</c:v>
                </c:pt>
                <c:pt idx="10">
                  <c:v>leukocyte cell-cell adhesion</c:v>
                </c:pt>
                <c:pt idx="11">
                  <c:v>biological regulation</c:v>
                </c:pt>
                <c:pt idx="12">
                  <c:v>regulation of immune system process</c:v>
                </c:pt>
                <c:pt idx="13">
                  <c:v>regulation of immune response</c:v>
                </c:pt>
                <c:pt idx="14">
                  <c:v>Immune system process</c:v>
                </c:pt>
              </c:strCache>
            </c:strRef>
          </c:cat>
          <c:val>
            <c:numRef>
              <c:f>downregulated_genes_BP_all!$G$2:$G$16</c:f>
              <c:numCache>
                <c:formatCode>General</c:formatCode>
                <c:ptCount val="15"/>
                <c:pt idx="0">
                  <c:v>1.4089353929735009</c:v>
                </c:pt>
                <c:pt idx="1">
                  <c:v>1.4089353929735009</c:v>
                </c:pt>
                <c:pt idx="2">
                  <c:v>1.4202164033831899</c:v>
                </c:pt>
                <c:pt idx="3">
                  <c:v>1.6020599913279623</c:v>
                </c:pt>
                <c:pt idx="4">
                  <c:v>2.2924298239020637</c:v>
                </c:pt>
                <c:pt idx="5">
                  <c:v>2.2924298239020637</c:v>
                </c:pt>
                <c:pt idx="6">
                  <c:v>2.3467874862246565</c:v>
                </c:pt>
                <c:pt idx="7">
                  <c:v>2.3565473235138126</c:v>
                </c:pt>
                <c:pt idx="8">
                  <c:v>2.3872161432802645</c:v>
                </c:pt>
                <c:pt idx="9">
                  <c:v>2.3872161432802645</c:v>
                </c:pt>
                <c:pt idx="10">
                  <c:v>2.3979400086720375</c:v>
                </c:pt>
                <c:pt idx="11">
                  <c:v>2.9208187539523753</c:v>
                </c:pt>
                <c:pt idx="12">
                  <c:v>3.1135092748275182</c:v>
                </c:pt>
                <c:pt idx="13">
                  <c:v>3.1804560644581312</c:v>
                </c:pt>
                <c:pt idx="14">
                  <c:v>3.30980391997148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51-4E3C-994D-59FC40C2ED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84348288"/>
        <c:axId val="220478848"/>
      </c:barChart>
      <c:catAx>
        <c:axId val="84348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0478848"/>
        <c:crosses val="autoZero"/>
        <c:auto val="1"/>
        <c:lblAlgn val="ctr"/>
        <c:lblOffset val="100"/>
        <c:noMultiLvlLbl val="0"/>
      </c:catAx>
      <c:valAx>
        <c:axId val="220478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48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Gene ontologies of upregulated</a:t>
            </a:r>
            <a:r>
              <a:rPr lang="en-US" baseline="0" dirty="0" smtClean="0"/>
              <a:t> </a:t>
            </a:r>
            <a:r>
              <a:rPr lang="en-US" baseline="0" dirty="0"/>
              <a:t>genes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Upregulated_genes_Bp_All!$B$2:$B$16</c:f>
              <c:strCache>
                <c:ptCount val="15"/>
                <c:pt idx="0">
                  <c:v>response to external stimulus</c:v>
                </c:pt>
                <c:pt idx="1">
                  <c:v>response to other organism</c:v>
                </c:pt>
                <c:pt idx="2">
                  <c:v>response to external biotic stimulus</c:v>
                </c:pt>
                <c:pt idx="3">
                  <c:v>defense response to other organism</c:v>
                </c:pt>
                <c:pt idx="4">
                  <c:v>response to biotic stimulus</c:v>
                </c:pt>
                <c:pt idx="5">
                  <c:v>humoral immune response</c:v>
                </c:pt>
                <c:pt idx="6">
                  <c:v>defense response to bacterium</c:v>
                </c:pt>
                <c:pt idx="7">
                  <c:v>regulation of immune response</c:v>
                </c:pt>
                <c:pt idx="8">
                  <c:v>response to bacterium</c:v>
                </c:pt>
                <c:pt idx="9">
                  <c:v>response to stress</c:v>
                </c:pt>
                <c:pt idx="10">
                  <c:v>regulation of immune system process</c:v>
                </c:pt>
                <c:pt idx="11">
                  <c:v>innate immune response</c:v>
                </c:pt>
                <c:pt idx="12">
                  <c:v>Immune response</c:v>
                </c:pt>
                <c:pt idx="13">
                  <c:v>defense response</c:v>
                </c:pt>
                <c:pt idx="14">
                  <c:v>Immune system process</c:v>
                </c:pt>
              </c:strCache>
            </c:strRef>
          </c:cat>
          <c:val>
            <c:numRef>
              <c:f>Upregulated_genes_Bp_All!$G$2:$G$16</c:f>
              <c:numCache>
                <c:formatCode>General</c:formatCode>
                <c:ptCount val="15"/>
                <c:pt idx="0">
                  <c:v>5.1870866433571443</c:v>
                </c:pt>
                <c:pt idx="1">
                  <c:v>5.2441251443275085</c:v>
                </c:pt>
                <c:pt idx="2">
                  <c:v>5.2441251443275085</c:v>
                </c:pt>
                <c:pt idx="3">
                  <c:v>5.5228787452803374</c:v>
                </c:pt>
                <c:pt idx="4">
                  <c:v>5.9208187539523749</c:v>
                </c:pt>
                <c:pt idx="5">
                  <c:v>6.1674910872937634</c:v>
                </c:pt>
                <c:pt idx="6">
                  <c:v>6.5686362358410131</c:v>
                </c:pt>
                <c:pt idx="7">
                  <c:v>6.5850266520291818</c:v>
                </c:pt>
                <c:pt idx="8">
                  <c:v>6.6989700043360187</c:v>
                </c:pt>
                <c:pt idx="9">
                  <c:v>6.795880017344075</c:v>
                </c:pt>
                <c:pt idx="10">
                  <c:v>7.0087739243075049</c:v>
                </c:pt>
                <c:pt idx="11">
                  <c:v>10.065501548756432</c:v>
                </c:pt>
                <c:pt idx="12">
                  <c:v>12.481486060122112</c:v>
                </c:pt>
                <c:pt idx="13">
                  <c:v>13.568636235841012</c:v>
                </c:pt>
                <c:pt idx="14">
                  <c:v>14.5086383061657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73-438F-9266-39DD931A76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86096896"/>
        <c:axId val="86098688"/>
      </c:barChart>
      <c:catAx>
        <c:axId val="860968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098688"/>
        <c:crosses val="autoZero"/>
        <c:auto val="1"/>
        <c:lblAlgn val="ctr"/>
        <c:lblOffset val="100"/>
        <c:noMultiLvlLbl val="0"/>
      </c:catAx>
      <c:valAx>
        <c:axId val="86098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096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56714785651794"/>
          <c:y val="3.2289945238326692E-2"/>
          <c:w val="0.8376550743657043"/>
          <c:h val="0.6877384076990376"/>
        </c:manualLayout>
      </c:layout>
      <c:barChart>
        <c:barDir val="col"/>
        <c:grouping val="clustered"/>
        <c:varyColors val="0"/>
        <c:ser>
          <c:idx val="0"/>
          <c:order val="0"/>
          <c:tx>
            <c:v>Background hypermethylated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Distribution_DMG!$C$2:$F$2</c:f>
              <c:strCache>
                <c:ptCount val="4"/>
                <c:pt idx="0">
                  <c:v>Island</c:v>
                </c:pt>
                <c:pt idx="1">
                  <c:v>Open sea</c:v>
                </c:pt>
                <c:pt idx="2">
                  <c:v>Shelf</c:v>
                </c:pt>
                <c:pt idx="3">
                  <c:v>Shore</c:v>
                </c:pt>
              </c:strCache>
            </c:strRef>
          </c:cat>
          <c:val>
            <c:numRef>
              <c:f>Distribution_DMG!$H$41:$K$41</c:f>
              <c:numCache>
                <c:formatCode>0.00000</c:formatCode>
                <c:ptCount val="4"/>
                <c:pt idx="0">
                  <c:v>0.29434284999999999</c:v>
                </c:pt>
                <c:pt idx="1">
                  <c:v>0.39368044000000002</c:v>
                </c:pt>
                <c:pt idx="2">
                  <c:v>9.8838019999999999E-2</c:v>
                </c:pt>
                <c:pt idx="3">
                  <c:v>0.21313868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CA-409F-90A9-346CA92FAB88}"/>
            </c:ext>
          </c:extLst>
        </c:ser>
        <c:ser>
          <c:idx val="1"/>
          <c:order val="1"/>
          <c:tx>
            <c:v>Differentially hypermethylated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cat>
            <c:strRef>
              <c:f>Distribution_DMG!$C$2:$F$2</c:f>
              <c:strCache>
                <c:ptCount val="4"/>
                <c:pt idx="0">
                  <c:v>Island</c:v>
                </c:pt>
                <c:pt idx="1">
                  <c:v>Open sea</c:v>
                </c:pt>
                <c:pt idx="2">
                  <c:v>Shelf</c:v>
                </c:pt>
                <c:pt idx="3">
                  <c:v>Shore</c:v>
                </c:pt>
              </c:strCache>
            </c:strRef>
          </c:cat>
          <c:val>
            <c:numRef>
              <c:f>Distribution_DMG!$H$42:$K$42</c:f>
              <c:numCache>
                <c:formatCode>General</c:formatCode>
                <c:ptCount val="4"/>
                <c:pt idx="0">
                  <c:v>0.15384615384615385</c:v>
                </c:pt>
                <c:pt idx="1">
                  <c:v>0.54545454545454541</c:v>
                </c:pt>
                <c:pt idx="2">
                  <c:v>0.11188811188811189</c:v>
                </c:pt>
                <c:pt idx="3">
                  <c:v>0.18881118881118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CA-409F-90A9-346CA92FAB88}"/>
            </c:ext>
          </c:extLst>
        </c:ser>
        <c:ser>
          <c:idx val="2"/>
          <c:order val="2"/>
          <c:tx>
            <c:v>Background hypomethylated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  <a:effectLst/>
          </c:spPr>
          <c:invertIfNegative val="0"/>
          <c:cat>
            <c:strRef>
              <c:f>Distribution_DMG!$C$2:$F$2</c:f>
              <c:strCache>
                <c:ptCount val="4"/>
                <c:pt idx="0">
                  <c:v>Island</c:v>
                </c:pt>
                <c:pt idx="1">
                  <c:v>Open sea</c:v>
                </c:pt>
                <c:pt idx="2">
                  <c:v>Shelf</c:v>
                </c:pt>
                <c:pt idx="3">
                  <c:v>Shore</c:v>
                </c:pt>
              </c:strCache>
            </c:strRef>
          </c:cat>
          <c:val>
            <c:numRef>
              <c:f>Distribution_DMG!$H$44:$K$44</c:f>
              <c:numCache>
                <c:formatCode>0.00000</c:formatCode>
                <c:ptCount val="4"/>
                <c:pt idx="0">
                  <c:v>0.34279788999999999</c:v>
                </c:pt>
                <c:pt idx="1">
                  <c:v>0.31605696</c:v>
                </c:pt>
                <c:pt idx="2">
                  <c:v>8.8752410000000004E-2</c:v>
                </c:pt>
                <c:pt idx="3">
                  <c:v>0.25239273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2CA-409F-90A9-346CA92FAB88}"/>
            </c:ext>
          </c:extLst>
        </c:ser>
        <c:ser>
          <c:idx val="3"/>
          <c:order val="3"/>
          <c:tx>
            <c:v>Differentially hypomethylated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cat>
            <c:strRef>
              <c:f>Distribution_DMG!$C$2:$F$2</c:f>
              <c:strCache>
                <c:ptCount val="4"/>
                <c:pt idx="0">
                  <c:v>Island</c:v>
                </c:pt>
                <c:pt idx="1">
                  <c:v>Open sea</c:v>
                </c:pt>
                <c:pt idx="2">
                  <c:v>Shelf</c:v>
                </c:pt>
                <c:pt idx="3">
                  <c:v>Shore</c:v>
                </c:pt>
              </c:strCache>
            </c:strRef>
          </c:cat>
          <c:val>
            <c:numRef>
              <c:f>Distribution_DMG!$H$45:$K$45</c:f>
              <c:numCache>
                <c:formatCode>0.00000</c:formatCode>
                <c:ptCount val="4"/>
                <c:pt idx="0">
                  <c:v>2.9411764705882353E-2</c:v>
                </c:pt>
                <c:pt idx="1">
                  <c:v>0.60230179028132991</c:v>
                </c:pt>
                <c:pt idx="2">
                  <c:v>0.15089514066496162</c:v>
                </c:pt>
                <c:pt idx="3">
                  <c:v>0.217391304347826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2CA-409F-90A9-346CA92FAB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4125440"/>
        <c:axId val="174127360"/>
      </c:barChart>
      <c:catAx>
        <c:axId val="174125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127360"/>
        <c:crosses val="autoZero"/>
        <c:auto val="1"/>
        <c:lblAlgn val="ctr"/>
        <c:lblOffset val="100"/>
        <c:noMultiLvlLbl val="0"/>
      </c:catAx>
      <c:valAx>
        <c:axId val="1741273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port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125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02667104111986"/>
          <c:y val="5.7815689705453485E-4"/>
          <c:w val="0.8502213473315835"/>
          <c:h val="0.15682925051035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21981627296587"/>
          <c:y val="4.2083333333333355E-2"/>
          <c:w val="0.86322462817147849"/>
          <c:h val="0.74461395450568679"/>
        </c:manualLayout>
      </c:layout>
      <c:barChart>
        <c:barDir val="col"/>
        <c:grouping val="clustered"/>
        <c:varyColors val="0"/>
        <c:ser>
          <c:idx val="0"/>
          <c:order val="0"/>
          <c:tx>
            <c:v>Background hypermethylated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Distribution_DMG!$H$15:$N$15</c:f>
              <c:strCache>
                <c:ptCount val="7"/>
                <c:pt idx="0">
                  <c:v>Body</c:v>
                </c:pt>
                <c:pt idx="1">
                  <c:v>IGR</c:v>
                </c:pt>
                <c:pt idx="2">
                  <c:v>3'UTR</c:v>
                </c:pt>
                <c:pt idx="3">
                  <c:v>5'UTR</c:v>
                </c:pt>
                <c:pt idx="4">
                  <c:v>1stExon</c:v>
                </c:pt>
                <c:pt idx="5">
                  <c:v>TSS1500</c:v>
                </c:pt>
                <c:pt idx="6">
                  <c:v>TSS200</c:v>
                </c:pt>
              </c:strCache>
            </c:strRef>
          </c:cat>
          <c:val>
            <c:numRef>
              <c:f>Distribution_DMG!$Y$16:$AE$16</c:f>
              <c:numCache>
                <c:formatCode>0.00000</c:formatCode>
                <c:ptCount val="7"/>
                <c:pt idx="0">
                  <c:v>0.33643643000000001</c:v>
                </c:pt>
                <c:pt idx="1">
                  <c:v>0.24189759999999999</c:v>
                </c:pt>
                <c:pt idx="2">
                  <c:v>3.582494E-2</c:v>
                </c:pt>
                <c:pt idx="3">
                  <c:v>8.6785890000000004E-2</c:v>
                </c:pt>
                <c:pt idx="4">
                  <c:v>4.6676179999999998E-2</c:v>
                </c:pt>
                <c:pt idx="5">
                  <c:v>0.13477343999999999</c:v>
                </c:pt>
                <c:pt idx="6">
                  <c:v>0.11760552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60B-49E7-9593-0C31A57EBF7A}"/>
            </c:ext>
          </c:extLst>
        </c:ser>
        <c:ser>
          <c:idx val="1"/>
          <c:order val="1"/>
          <c:tx>
            <c:v>Differentially hypermethylated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cat>
            <c:strRef>
              <c:f>Distribution_DMG!$H$15:$N$15</c:f>
              <c:strCache>
                <c:ptCount val="7"/>
                <c:pt idx="0">
                  <c:v>Body</c:v>
                </c:pt>
                <c:pt idx="1">
                  <c:v>IGR</c:v>
                </c:pt>
                <c:pt idx="2">
                  <c:v>3'UTR</c:v>
                </c:pt>
                <c:pt idx="3">
                  <c:v>5'UTR</c:v>
                </c:pt>
                <c:pt idx="4">
                  <c:v>1stExon</c:v>
                </c:pt>
                <c:pt idx="5">
                  <c:v>TSS1500</c:v>
                </c:pt>
                <c:pt idx="6">
                  <c:v>TSS200</c:v>
                </c:pt>
              </c:strCache>
            </c:strRef>
          </c:cat>
          <c:val>
            <c:numRef>
              <c:f>Distribution_DMG!$Y$17:$AE$17</c:f>
              <c:numCache>
                <c:formatCode>General</c:formatCode>
                <c:ptCount val="7"/>
                <c:pt idx="0">
                  <c:v>0.47552447552447552</c:v>
                </c:pt>
                <c:pt idx="1">
                  <c:v>0.17482517482517482</c:v>
                </c:pt>
                <c:pt idx="2">
                  <c:v>4.195804195804196E-2</c:v>
                </c:pt>
                <c:pt idx="3">
                  <c:v>0.1048951048951049</c:v>
                </c:pt>
                <c:pt idx="4">
                  <c:v>4.195804195804196E-2</c:v>
                </c:pt>
                <c:pt idx="5">
                  <c:v>5.5944055944055944E-2</c:v>
                </c:pt>
                <c:pt idx="6">
                  <c:v>0.10489510489510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60B-49E7-9593-0C31A57EBF7A}"/>
            </c:ext>
          </c:extLst>
        </c:ser>
        <c:ser>
          <c:idx val="2"/>
          <c:order val="2"/>
          <c:tx>
            <c:v>Background hypomethylated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  <a:effectLst/>
          </c:spPr>
          <c:invertIfNegative val="0"/>
          <c:cat>
            <c:strRef>
              <c:f>Distribution_DMG!$H$15:$N$15</c:f>
              <c:strCache>
                <c:ptCount val="7"/>
                <c:pt idx="0">
                  <c:v>Body</c:v>
                </c:pt>
                <c:pt idx="1">
                  <c:v>IGR</c:v>
                </c:pt>
                <c:pt idx="2">
                  <c:v>3'UTR</c:v>
                </c:pt>
                <c:pt idx="3">
                  <c:v>5'UTR</c:v>
                </c:pt>
                <c:pt idx="4">
                  <c:v>1stExon</c:v>
                </c:pt>
                <c:pt idx="5">
                  <c:v>TSS1500</c:v>
                </c:pt>
                <c:pt idx="6">
                  <c:v>TSS200</c:v>
                </c:pt>
              </c:strCache>
            </c:strRef>
          </c:cat>
          <c:val>
            <c:numRef>
              <c:f>Distribution_DMG!$Y$19:$AE$19</c:f>
              <c:numCache>
                <c:formatCode>0.00000</c:formatCode>
                <c:ptCount val="7"/>
                <c:pt idx="0">
                  <c:v>0.33056840999999998</c:v>
                </c:pt>
                <c:pt idx="1">
                  <c:v>0.23685329999999999</c:v>
                </c:pt>
                <c:pt idx="2">
                  <c:v>3.5337019999999997E-2</c:v>
                </c:pt>
                <c:pt idx="3">
                  <c:v>9.1273640000000003E-2</c:v>
                </c:pt>
                <c:pt idx="4">
                  <c:v>4.899328E-2</c:v>
                </c:pt>
                <c:pt idx="5">
                  <c:v>0.15283759999999999</c:v>
                </c:pt>
                <c:pt idx="6">
                  <c:v>0.10413675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60B-49E7-9593-0C31A57EBF7A}"/>
            </c:ext>
          </c:extLst>
        </c:ser>
        <c:ser>
          <c:idx val="3"/>
          <c:order val="3"/>
          <c:tx>
            <c:v>Differentially hypomethylated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cat>
            <c:strRef>
              <c:f>Distribution_DMG!$H$15:$N$15</c:f>
              <c:strCache>
                <c:ptCount val="7"/>
                <c:pt idx="0">
                  <c:v>Body</c:v>
                </c:pt>
                <c:pt idx="1">
                  <c:v>IGR</c:v>
                </c:pt>
                <c:pt idx="2">
                  <c:v>3'UTR</c:v>
                </c:pt>
                <c:pt idx="3">
                  <c:v>5'UTR</c:v>
                </c:pt>
                <c:pt idx="4">
                  <c:v>1stExon</c:v>
                </c:pt>
                <c:pt idx="5">
                  <c:v>TSS1500</c:v>
                </c:pt>
                <c:pt idx="6">
                  <c:v>TSS200</c:v>
                </c:pt>
              </c:strCache>
            </c:strRef>
          </c:cat>
          <c:val>
            <c:numRef>
              <c:f>Distribution_DMG!$Y$20:$AE$20</c:f>
              <c:numCache>
                <c:formatCode>0.00000</c:formatCode>
                <c:ptCount val="7"/>
                <c:pt idx="0">
                  <c:v>0.45268542199488493</c:v>
                </c:pt>
                <c:pt idx="1">
                  <c:v>0.20971867007672634</c:v>
                </c:pt>
                <c:pt idx="2">
                  <c:v>4.3478260869565216E-2</c:v>
                </c:pt>
                <c:pt idx="3">
                  <c:v>0.1010230179028133</c:v>
                </c:pt>
                <c:pt idx="4">
                  <c:v>1.5345268542199489E-2</c:v>
                </c:pt>
                <c:pt idx="5">
                  <c:v>0.13427109974424553</c:v>
                </c:pt>
                <c:pt idx="6">
                  <c:v>4.347826086956521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60B-49E7-9593-0C31A57EBF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4798976"/>
        <c:axId val="166580224"/>
      </c:barChart>
      <c:catAx>
        <c:axId val="224798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6580224"/>
        <c:crosses val="autoZero"/>
        <c:auto val="1"/>
        <c:lblAlgn val="ctr"/>
        <c:lblOffset val="100"/>
        <c:noMultiLvlLbl val="0"/>
      </c:catAx>
      <c:valAx>
        <c:axId val="166580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port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47989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3322265966754155"/>
          <c:y val="6.1270628842627552E-2"/>
          <c:w val="0.72511067366579174"/>
          <c:h val="0.2041013195268400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H$2:$H$11</c:f>
              <c:strCache>
                <c:ptCount val="10"/>
                <c:pt idx="0">
                  <c:v>Adaptive immunity </c:v>
                </c:pt>
                <c:pt idx="1">
                  <c:v>Immunity</c:v>
                </c:pt>
                <c:pt idx="2">
                  <c:v>Intracellular signal transduction</c:v>
                </c:pt>
                <c:pt idx="3">
                  <c:v>Phosphoprotein</c:v>
                </c:pt>
                <c:pt idx="4">
                  <c:v>T cell receptor signaling pathway</c:v>
                </c:pt>
                <c:pt idx="5">
                  <c:v>Apoptotic process</c:v>
                </c:pt>
                <c:pt idx="6">
                  <c:v>Kinase</c:v>
                </c:pt>
                <c:pt idx="7">
                  <c:v>Membrane</c:v>
                </c:pt>
                <c:pt idx="8">
                  <c:v>ATP-binding</c:v>
                </c:pt>
                <c:pt idx="9">
                  <c:v>Inflammatory response</c:v>
                </c:pt>
              </c:strCache>
            </c:strRef>
          </c:cat>
          <c:val>
            <c:numRef>
              <c:f>Sheet1!$K$2:$K$11</c:f>
              <c:numCache>
                <c:formatCode>0.00</c:formatCode>
                <c:ptCount val="10"/>
                <c:pt idx="0">
                  <c:v>5.431798275933005</c:v>
                </c:pt>
                <c:pt idx="1">
                  <c:v>2.8239087409443187</c:v>
                </c:pt>
                <c:pt idx="2">
                  <c:v>2.3565473235138126</c:v>
                </c:pt>
                <c:pt idx="3">
                  <c:v>2.2924298239020637</c:v>
                </c:pt>
                <c:pt idx="4">
                  <c:v>2.0268721464003012</c:v>
                </c:pt>
                <c:pt idx="5">
                  <c:v>2</c:v>
                </c:pt>
                <c:pt idx="6">
                  <c:v>1.7958800173440752</c:v>
                </c:pt>
                <c:pt idx="7">
                  <c:v>1.7212463990471711</c:v>
                </c:pt>
                <c:pt idx="8">
                  <c:v>1.6575773191777938</c:v>
                </c:pt>
                <c:pt idx="9">
                  <c:v>1.38721614328026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A4-4BF9-8AC9-84FA780EF3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07886208"/>
        <c:axId val="207912960"/>
      </c:barChart>
      <c:catAx>
        <c:axId val="2078862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Gene ontologies of hypermethylated genes</a:t>
                </a:r>
              </a:p>
            </c:rich>
          </c:tx>
          <c:layout/>
          <c:overlay val="0"/>
          <c:spPr>
            <a:solidFill>
              <a:sysClr val="window" lastClr="FFFFFF"/>
            </a:solidFill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912960"/>
        <c:crosses val="autoZero"/>
        <c:auto val="1"/>
        <c:lblAlgn val="ctr"/>
        <c:lblOffset val="100"/>
        <c:tickMarkSkip val="10"/>
        <c:noMultiLvlLbl val="0"/>
      </c:catAx>
      <c:valAx>
        <c:axId val="2079129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50" b="1"/>
                  <a:t>-log10 (BH-p.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886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043030377404318"/>
          <c:y val="3.8323348474911784E-2"/>
          <c:w val="0.53890624448091562"/>
          <c:h val="0.82109936711152598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Sheet1!$M$2:$M$11</c:f>
              <c:strCache>
                <c:ptCount val="10"/>
                <c:pt idx="0">
                  <c:v>Alternative splicing </c:v>
                </c:pt>
                <c:pt idx="1">
                  <c:v>Phosphoprotein</c:v>
                </c:pt>
                <c:pt idx="2">
                  <c:v>Polymorphism</c:v>
                </c:pt>
                <c:pt idx="3">
                  <c:v>Cytoplasm </c:v>
                </c:pt>
                <c:pt idx="4">
                  <c:v>Host-virus interaction</c:v>
                </c:pt>
                <c:pt idx="5">
                  <c:v>Cytoplasm </c:v>
                </c:pt>
                <c:pt idx="6">
                  <c:v>Cytosol</c:v>
                </c:pt>
                <c:pt idx="7">
                  <c:v>Protein binding </c:v>
                </c:pt>
                <c:pt idx="8">
                  <c:v>Methylated histone binding</c:v>
                </c:pt>
                <c:pt idx="9">
                  <c:v>Positive regulation of transcription</c:v>
                </c:pt>
              </c:strCache>
            </c:strRef>
          </c:cat>
          <c:val>
            <c:numRef>
              <c:f>Sheet1!$P$2:$P$11</c:f>
              <c:numCache>
                <c:formatCode>0.00</c:formatCode>
                <c:ptCount val="10"/>
                <c:pt idx="0">
                  <c:v>14.721246399047171</c:v>
                </c:pt>
                <c:pt idx="1">
                  <c:v>11.853871964321762</c:v>
                </c:pt>
                <c:pt idx="2">
                  <c:v>8.6382721639824069</c:v>
                </c:pt>
                <c:pt idx="3">
                  <c:v>3.6575773191777938</c:v>
                </c:pt>
                <c:pt idx="4">
                  <c:v>3.0506099933550872</c:v>
                </c:pt>
                <c:pt idx="5">
                  <c:v>2.9586073148417751</c:v>
                </c:pt>
                <c:pt idx="6">
                  <c:v>1.7212463990471711</c:v>
                </c:pt>
                <c:pt idx="7">
                  <c:v>1.3665315444204136</c:v>
                </c:pt>
                <c:pt idx="8">
                  <c:v>1.3565473235138126</c:v>
                </c:pt>
                <c:pt idx="9">
                  <c:v>1.3372421683184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6B-47D4-AEF8-F300A8190B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07924608"/>
        <c:axId val="207930880"/>
      </c:barChart>
      <c:catAx>
        <c:axId val="2079246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Gene ontologies of </a:t>
                </a:r>
                <a:endParaRPr lang="en-US" sz="1200" b="1" dirty="0" smtClean="0">
                  <a:solidFill>
                    <a:schemeClr val="tx1"/>
                  </a:solidFill>
                </a:endParaRPr>
              </a:p>
              <a:p>
                <a:pPr>
                  <a:defRPr/>
                </a:pPr>
                <a:r>
                  <a:rPr lang="en-US" sz="1200" b="1" dirty="0" err="1" smtClean="0">
                    <a:solidFill>
                      <a:schemeClr val="tx1"/>
                    </a:solidFill>
                  </a:rPr>
                  <a:t>hypomethylated</a:t>
                </a:r>
                <a:r>
                  <a:rPr lang="en-US" sz="1200" b="1" dirty="0" smtClean="0">
                    <a:solidFill>
                      <a:schemeClr val="tx1"/>
                    </a:solidFill>
                  </a:rPr>
                  <a:t> </a:t>
                </a:r>
                <a:r>
                  <a:rPr lang="en-US" sz="1200" b="1" dirty="0">
                    <a:solidFill>
                      <a:schemeClr val="tx1"/>
                    </a:solidFill>
                  </a:rPr>
                  <a:t>genes</a:t>
                </a:r>
              </a:p>
            </c:rich>
          </c:tx>
          <c:layout>
            <c:manualLayout>
              <c:xMode val="edge"/>
              <c:yMode val="edge"/>
              <c:x val="0"/>
              <c:y val="0.234836963154598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930880"/>
        <c:crosses val="autoZero"/>
        <c:auto val="1"/>
        <c:lblAlgn val="ctr"/>
        <c:lblOffset val="100"/>
        <c:noMultiLvlLbl val="0"/>
      </c:catAx>
      <c:valAx>
        <c:axId val="2079308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50" b="1"/>
                  <a:t>-log10 (BH-p.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924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0C5AEF-7A3E-42AC-8A4E-5A02CB92A9E5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9C0D09-DEB2-4C23-8E6C-5822A2EB9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749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499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013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75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015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416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236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649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382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055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188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777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3D004-E164-42B4-A1AB-7A8EE2399A89}" type="datetimeFigureOut">
              <a:rPr lang="en-US" smtClean="0"/>
              <a:t>7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6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7891B-1319-4DB0-9B79-4280F839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749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84" b="3344"/>
          <a:stretch/>
        </p:blipFill>
        <p:spPr bwMode="auto">
          <a:xfrm>
            <a:off x="81759" y="1752600"/>
            <a:ext cx="2842415" cy="266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56" b="2672"/>
          <a:stretch/>
        </p:blipFill>
        <p:spPr bwMode="auto">
          <a:xfrm>
            <a:off x="3124200" y="1752600"/>
            <a:ext cx="3003064" cy="266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61" b="4180"/>
          <a:stretch/>
        </p:blipFill>
        <p:spPr bwMode="auto">
          <a:xfrm>
            <a:off x="6126225" y="1752601"/>
            <a:ext cx="2913000" cy="266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143250" y="87869"/>
            <a:ext cx="2372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 1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533400" y="1391289"/>
            <a:ext cx="18194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Rheumatic diseases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3846286" y="1383268"/>
            <a:ext cx="13378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Viral infection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6398741" y="1411160"/>
            <a:ext cx="21088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nflammation response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0746827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7147770"/>
              </p:ext>
            </p:extLst>
          </p:nvPr>
        </p:nvGraphicFramePr>
        <p:xfrm>
          <a:off x="0" y="1183084"/>
          <a:ext cx="4495799" cy="41398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50187324"/>
              </p:ext>
            </p:extLst>
          </p:nvPr>
        </p:nvGraphicFramePr>
        <p:xfrm>
          <a:off x="4495800" y="1183084"/>
          <a:ext cx="4648200" cy="4202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362200" y="5259118"/>
            <a:ext cx="63847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-log10(</a:t>
            </a:r>
            <a:r>
              <a:rPr lang="en-US" sz="1050" b="1" i="1" dirty="0"/>
              <a:t>p</a:t>
            </a:r>
            <a:r>
              <a:rPr lang="en-US" sz="1050" b="1" dirty="0"/>
              <a:t>-value)                                                                                                                                       -log10(</a:t>
            </a:r>
            <a:r>
              <a:rPr lang="en-US" sz="1050" b="1" i="1" dirty="0"/>
              <a:t>p</a:t>
            </a:r>
            <a:r>
              <a:rPr lang="en-US" sz="1050" b="1" dirty="0"/>
              <a:t>-value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200400" y="381000"/>
            <a:ext cx="2947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Supplemental  Figure 2</a:t>
            </a:r>
            <a:endParaRPr lang="en-US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39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2503791" y="1682508"/>
          <a:ext cx="3429000" cy="1620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2503791" y="3788920"/>
          <a:ext cx="3429000" cy="1620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503791" y="1405509"/>
            <a:ext cx="26627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A. Distribution of DMPs on genom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03791" y="3505518"/>
            <a:ext cx="250081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A. Distribution of DMPs on gen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00400" y="381000"/>
            <a:ext cx="2947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Supplemental  Figure 3</a:t>
            </a:r>
            <a:endParaRPr lang="en-US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301813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4982764" y="2054115"/>
          <a:ext cx="3868628" cy="29682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0030606"/>
              </p:ext>
            </p:extLst>
          </p:nvPr>
        </p:nvGraphicFramePr>
        <p:xfrm>
          <a:off x="200451" y="1937742"/>
          <a:ext cx="4473817" cy="29825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200400" y="381000"/>
            <a:ext cx="2947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Supplemental  Figure 4</a:t>
            </a:r>
            <a:endParaRPr lang="en-US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317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5</TotalTime>
  <Words>70</Words>
  <Application>Microsoft Office PowerPoint</Application>
  <PresentationFormat>On-screen Show (4:3)</PresentationFormat>
  <Paragraphs>1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tao</dc:creator>
  <cp:lastModifiedBy>Quan Li</cp:lastModifiedBy>
  <cp:revision>40</cp:revision>
  <dcterms:created xsi:type="dcterms:W3CDTF">2017-05-17T14:35:49Z</dcterms:created>
  <dcterms:modified xsi:type="dcterms:W3CDTF">2018-07-27T22:33:24Z</dcterms:modified>
</cp:coreProperties>
</file>